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7315200" cy="96012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34061E45-73CA-42BD-9EFD-E3FA892B8A1F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77875" y="1200150"/>
            <a:ext cx="57594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F1E7A82C-F992-4EA9-ADB9-90208968E1A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78498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8E2605-8D70-46E2-808F-986C74B128BA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860415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444B8-5EEB-87A5-67F9-0864BF9B4A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0273BB-7C17-75A1-321D-44792CEBAB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E7CBDF-1D02-96DD-6CA6-E5C2C6E68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B55915-8181-CF79-10C5-AEE65AD4C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28E4B-6655-FE85-557E-748D2D1AB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44691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B69283-E642-B44E-316B-E48F3AFAFD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DE262F-8007-3799-FEBA-06F780DBFB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CF8D22-9DD4-68A5-1BA6-04AE324F25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44E2A-7916-1B23-5472-232555DC6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BCA65-1515-F512-5635-7A8CE3B95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26034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5053DD-FEFA-EF6B-8EDC-1FA787E13B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99A458-BFB9-DBD2-D546-0D33C774E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EFB2B9-A1F1-31F5-88F8-F3F7D6F18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6B3FA-8E2B-B66A-87B0-740499CC0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BE4E81-A24A-AF46-7C6C-60E4CD890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38678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9EF0A-C657-5DD7-F00E-E339A8D0C4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B68091-65BB-BAC6-5560-CF4EA979A3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E26BA9-711F-AF73-5727-941231E70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7B0057-604D-3EFC-4E12-B7B0AA9FD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D23D38-AECA-8848-1A57-B674EB49E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65411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B6743-A97D-EA45-B5CB-40BE10070A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2E1251-56A0-F33D-3E3A-171CA1DF8F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BB963-EAA5-0CE0-235A-07E3CEEA9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8D0CB9-592D-3CF1-A814-21F508241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B56D7E-F568-AC59-AE0D-D537FC1E6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61030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A9A138-A6CD-8096-5C5E-05CCA89266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E82006-4951-DE8E-C313-F5C86061E3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718DC4-E28A-20B9-DF7A-5E5B96174F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833DC8-76AE-22C0-4E2B-13AA33517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5FE403-8CC7-8F75-B1E7-99D17BD54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CE979B-A670-B415-A10D-65E8CB635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82722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93A76-AE33-C033-1310-881D7D2D3B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340AE4-B4B9-F94B-9DB3-962D3D3058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9912EA-EE29-0EF5-8ADF-93B59BAD7A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178A22-0279-9D99-A0CB-89CF7A672E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1EFB21-7912-FA44-340D-9F70F74E8A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1FBDF3-2C1E-AD85-CE06-E9A7CB67A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7E05EB-99D0-F729-F822-647A8C1FD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8C51F1-696B-AD19-599E-9D536A015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68897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D7166-E7EE-90B1-436B-5817412B7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16F84B-1D6D-46A2-2420-5A283D005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4B2C65-6821-A583-8C54-8B74B051F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AC3C3E-4783-F04E-E18B-6CD0440FE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313934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924500-EAFB-4B49-C614-5420CD502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FF61A8-9136-C3A8-3FC7-B515DE3BE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07F9AD-8978-2A0F-3EEE-EAC7C54EC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7806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1EB2A-4644-4E94-818E-E4A6AB9AF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9D9E1F-D2CA-C90D-5503-A1CE208672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3632B9-169A-D295-0F99-A4AB36387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6E8408-2514-4AFF-7FDF-08C0FEA7B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969CB8-4455-7A99-3AD7-933D2FCF0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89BBAB-8E1E-4E2C-EF3B-60F1924FA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17861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AD8DDC-B5AE-98E6-B919-194F91513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C9656B-F558-3737-F061-E6980443D8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C6C0C2-EE86-3E98-D1EA-19D4B584CD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37CDAE-E0C7-CD23-7E8F-BCACFEED96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EA8C02-354D-4A88-F22D-4CEDC80F7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4A9C07-C134-6803-FAF5-E55649144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7703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62974B-1265-D8F2-DB30-CE8176CDB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B75F09-AA1D-ED07-67BB-F3CEA4BD1D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7D85ED-3C23-477B-CA62-D925EF20CE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648311-CA65-4BB2-BAEB-80620AED09AD}" type="datetimeFigureOut">
              <a:rPr lang="nb-NO" smtClean="0"/>
              <a:t>25.11.2025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C6269E-FC6F-87DD-066A-1128E283BD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1B4EAF-D6DF-A93C-01A7-66BA4AA6D5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A0B502-464F-4A6A-8FF4-49B0DFCCAE0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25868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829B417-7166-9EAB-DBA8-1853C7ED20E2}"/>
              </a:ext>
            </a:extLst>
          </p:cNvPr>
          <p:cNvPicPr>
            <a:picLocks noChangeAspect="1"/>
          </p:cNvPicPr>
          <p:nvPr/>
        </p:nvPicPr>
        <p:blipFill>
          <a:blip r:embed="rId3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0000"/>
                    </a14:imgEffect>
                  </a14:imgLayer>
                </a14:imgProps>
              </a:ext>
            </a:extLst>
          </a:blip>
          <a:srcRect t="2329" r="1429"/>
          <a:stretch>
            <a:fillRect/>
          </a:stretch>
        </p:blipFill>
        <p:spPr>
          <a:xfrm>
            <a:off x="325066" y="0"/>
            <a:ext cx="5147222" cy="436418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8915F64-6C6E-4C14-590C-C0A7A643705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20000"/>
                    </a14:imgEffect>
                  </a14:imgLayer>
                </a14:imgProps>
              </a:ext>
            </a:extLst>
          </a:blip>
          <a:srcRect t="1" b="709"/>
          <a:stretch>
            <a:fillRect/>
          </a:stretch>
        </p:blipFill>
        <p:spPr>
          <a:xfrm>
            <a:off x="5638542" y="0"/>
            <a:ext cx="5147222" cy="436418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E58EE4C-D529-D3FC-23A3-C45F6DD15E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84855" y="4364182"/>
            <a:ext cx="1800909" cy="246610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BB6C100-F306-20C6-ED19-E227B02B92E0}"/>
              </a:ext>
            </a:extLst>
          </p:cNvPr>
          <p:cNvSpPr txBox="1"/>
          <p:nvPr/>
        </p:nvSpPr>
        <p:spPr>
          <a:xfrm>
            <a:off x="325066" y="4364182"/>
            <a:ext cx="848642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.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rected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yclic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on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cystic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ary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drom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ody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ss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x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eastfeeding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ight)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justing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maternal age,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cation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bacco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ag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ity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d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reenshots from dagitty</a:t>
            </a:r>
            <a:r>
              <a:rPr lang="nb-NO" sz="1200">
                <a:latin typeface="Times New Roman" panose="02020603050405020304" pitchFamily="18" charset="0"/>
                <a:cs typeface="Times New Roman" panose="02020603050405020304" pitchFamily="18" charset="0"/>
              </a:rPr>
              <a:t>.net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nb-NO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OS: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cystic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ary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drome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M: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abetes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litus</a:t>
            </a:r>
            <a:endParaRPr lang="nb-NO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: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stational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e</a:t>
            </a:r>
          </a:p>
          <a:p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CU: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wborn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nsive </a:t>
            </a:r>
            <a:r>
              <a:rPr lang="nb-NO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e</a:t>
            </a:r>
            <a:r>
              <a:rPr lang="nb-NO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t</a:t>
            </a:r>
          </a:p>
        </p:txBody>
      </p:sp>
    </p:spTree>
    <p:extLst>
      <p:ext uri="{BB962C8B-B14F-4D97-AF65-F5344CB8AC3E}">
        <p14:creationId xmlns:p14="http://schemas.microsoft.com/office/powerpoint/2010/main" val="3858515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e Engtrø Husby</dc:creator>
  <cp:lastModifiedBy>Anne Engtrø Husby</cp:lastModifiedBy>
  <cp:revision>1</cp:revision>
  <dcterms:created xsi:type="dcterms:W3CDTF">2025-11-25T12:37:24Z</dcterms:created>
  <dcterms:modified xsi:type="dcterms:W3CDTF">2025-11-25T12:40:42Z</dcterms:modified>
</cp:coreProperties>
</file>